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2" r:id="rId2"/>
  </p:sldIdLst>
  <p:sldSz cx="6264275" cy="8423275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78" autoAdjust="0"/>
    <p:restoredTop sz="94660"/>
  </p:normalViewPr>
  <p:slideViewPr>
    <p:cSldViewPr snapToGrid="0">
      <p:cViewPr varScale="1">
        <p:scale>
          <a:sx n="64" d="100"/>
          <a:sy n="64" d="100"/>
        </p:scale>
        <p:origin x="177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972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557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6889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679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2042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274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990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492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3816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401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65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503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55983921"/>
              </p:ext>
            </p:extLst>
          </p:nvPr>
        </p:nvGraphicFramePr>
        <p:xfrm>
          <a:off x="156411" y="1313501"/>
          <a:ext cx="5979694" cy="421207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360994">
                  <a:extLst>
                    <a:ext uri="{9D8B030D-6E8A-4147-A177-3AD203B41FA5}">
                      <a16:colId xmlns:a16="http://schemas.microsoft.com/office/drawing/2014/main" val="1184616847"/>
                    </a:ext>
                  </a:extLst>
                </a:gridCol>
                <a:gridCol w="785468">
                  <a:extLst>
                    <a:ext uri="{9D8B030D-6E8A-4147-A177-3AD203B41FA5}">
                      <a16:colId xmlns:a16="http://schemas.microsoft.com/office/drawing/2014/main" val="3645805644"/>
                    </a:ext>
                  </a:extLst>
                </a:gridCol>
                <a:gridCol w="1833232">
                  <a:extLst>
                    <a:ext uri="{9D8B030D-6E8A-4147-A177-3AD203B41FA5}">
                      <a16:colId xmlns:a16="http://schemas.microsoft.com/office/drawing/2014/main" val="4177411172"/>
                    </a:ext>
                  </a:extLst>
                </a:gridCol>
              </a:tblGrid>
              <a:tr h="266185">
                <a:tc gridSpan="3">
                  <a:txBody>
                    <a:bodyPr/>
                    <a:lstStyle/>
                    <a:p>
                      <a:pPr algn="l"/>
                      <a:r>
                        <a:rPr lang="en-US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ementary Table 2.</a:t>
                      </a:r>
                      <a:r>
                        <a:rPr lang="en-US" sz="11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 a</a:t>
                      </a:r>
                      <a:r>
                        <a:rPr lang="en-US" sz="11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ibodies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0685317"/>
                  </a:ext>
                </a:extLst>
              </a:tr>
              <a:tr h="266185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y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lution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plication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40563542"/>
                  </a:ext>
                </a:extLst>
              </a:tr>
              <a:tr h="433012"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K2</a:t>
                      </a:r>
                      <a:r>
                        <a:rPr lang="el-GR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Santa Cruz Biotechnology; sc-12738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</a:t>
                      </a:r>
                    </a:p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HC</a:t>
                      </a:r>
                    </a:p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C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2739521"/>
                  </a:ext>
                </a:extLst>
              </a:tr>
              <a:tr h="282914"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K2</a:t>
                      </a:r>
                      <a:r>
                        <a:rPr lang="en-US" sz="1100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r255</a:t>
                      </a:r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sz="11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BioSource</a:t>
                      </a:r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;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BS9704507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HC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6323244"/>
                  </a:ext>
                </a:extLst>
              </a:tr>
              <a:tr h="300790"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F1 (</a:t>
                      </a:r>
                      <a:r>
                        <a:rPr lang="en-US" sz="11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</a:t>
                      </a:r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isher Scientific;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44-752G; polyclonal; utilized with monoclonal CK2 antibody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0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HC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7914448"/>
                  </a:ext>
                </a:extLst>
              </a:tr>
              <a:tr h="288758"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F1 (Peter Davies; monoclonal;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utilized with polyclonal CK2tyr</a:t>
                      </a:r>
                      <a:r>
                        <a:rPr lang="en-US" sz="1100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5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R2B (</a:t>
                      </a:r>
                      <a:r>
                        <a:rPr lang="en-US" sz="1100" baseline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ss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, and NR2B</a:t>
                      </a:r>
                      <a:r>
                        <a:rPr lang="en-US" sz="1100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1480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tibodies)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0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HC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2100003"/>
                  </a:ext>
                </a:extLst>
              </a:tr>
              <a:tr h="300789"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ogenous mouse tau, R2295M  (in house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0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C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2171307"/>
                  </a:ext>
                </a:extLst>
              </a:tr>
              <a:tr h="312821"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2B (</a:t>
                      </a:r>
                      <a:r>
                        <a:rPr lang="en-US" sz="11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ss</a:t>
                      </a:r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tibodies; bs-0222R)</a:t>
                      </a:r>
                    </a:p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2B (</a:t>
                      </a:r>
                      <a:r>
                        <a:rPr lang="en-US" sz="11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mab</a:t>
                      </a:r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;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75-097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</a:t>
                      </a:r>
                    </a:p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300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HC, ICC (TBB study)</a:t>
                      </a:r>
                    </a:p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C (</a:t>
                      </a:r>
                      <a:r>
                        <a:rPr lang="en-US" sz="11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mantine</a:t>
                      </a:r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tudy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306149"/>
                  </a:ext>
                </a:extLst>
              </a:tr>
              <a:tr h="312821"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2B</a:t>
                      </a:r>
                      <a:r>
                        <a:rPr lang="en-US" sz="1100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1480</a:t>
                      </a:r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sz="11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ss</a:t>
                      </a:r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Antibodies;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s-5382R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HC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6663721"/>
                  </a:ext>
                </a:extLst>
              </a:tr>
              <a:tr h="300790"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D95 (</a:t>
                      </a:r>
                      <a:r>
                        <a:rPr lang="en-US" sz="11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isher Scientific; MA1-046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C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4431601"/>
                  </a:ext>
                </a:extLst>
              </a:tr>
              <a:tr h="300790"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EL (Santa Cruz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iotech; sc-58774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C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5426272"/>
                  </a:ext>
                </a:extLst>
              </a:tr>
              <a:tr h="300790"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130 (Santa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ruz Biotech; sc-55591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C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842268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600930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3374</TotalTime>
  <Words>147</Words>
  <Application>Microsoft Office PowerPoint</Application>
  <PresentationFormat>Custom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Penn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NDRUser</dc:creator>
  <cp:lastModifiedBy>Marshall, Courtney</cp:lastModifiedBy>
  <cp:revision>322</cp:revision>
  <cp:lastPrinted>2022-01-11T21:09:25Z</cp:lastPrinted>
  <dcterms:created xsi:type="dcterms:W3CDTF">2021-04-27T15:19:52Z</dcterms:created>
  <dcterms:modified xsi:type="dcterms:W3CDTF">2022-02-09T19:46:46Z</dcterms:modified>
</cp:coreProperties>
</file>